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149036C-5118-4362-883E-C848205839A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896AE8-154B-4AB6-BAA4-24B9120FFC9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FED758-0546-43E0-9C34-22C188EA52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1C6129-B429-4E6A-A6CA-89D01FD220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A5876-55F3-416B-BF18-FE5DCF221E5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153E20-26A0-4161-AEAC-281AE3AC89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94AC5E-F15D-480B-8EDF-F3B079A6E6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801E4-B06B-4B60-B70F-19AE647BB4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23861E-615B-4955-9F05-94BEF3F213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8325BD-0C1A-497D-8049-2F4F86CB94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CAD49E-E167-4554-B12D-AB4CEE0DF8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030B18-9944-4C4C-821C-62A3D63554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390166-D19F-4192-AD1C-04B816DDE4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6E1F04-B5B7-49B0-B350-62A7B8A7C2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DDC00C-6918-4A89-A3FB-C6E64F361C6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Chart 4" descr=""/>
          <p:cNvPicPr/>
          <p:nvPr/>
        </p:nvPicPr>
        <p:blipFill>
          <a:blip r:embed="rId1"/>
          <a:stretch/>
        </p:blipFill>
        <p:spPr>
          <a:xfrm>
            <a:off x="-30240" y="530280"/>
            <a:ext cx="4572000" cy="2743200"/>
          </a:xfrm>
          <a:prstGeom prst="rect">
            <a:avLst/>
          </a:prstGeom>
          <a:ln w="0">
            <a:noFill/>
          </a:ln>
        </p:spPr>
      </p:pic>
      <p:pic>
        <p:nvPicPr>
          <p:cNvPr id="49" name="Chart 5" descr=""/>
          <p:cNvPicPr/>
          <p:nvPr/>
        </p:nvPicPr>
        <p:blipFill>
          <a:blip r:embed="rId2"/>
          <a:stretch/>
        </p:blipFill>
        <p:spPr>
          <a:xfrm>
            <a:off x="4541760" y="536400"/>
            <a:ext cx="4572000" cy="2889360"/>
          </a:xfrm>
          <a:prstGeom prst="rect">
            <a:avLst/>
          </a:prstGeom>
          <a:ln w="0">
            <a:noFill/>
          </a:ln>
        </p:spPr>
      </p:pic>
      <p:sp>
        <p:nvSpPr>
          <p:cNvPr id="50" name="TextBox 1"/>
          <p:cNvSpPr/>
          <p:nvPr/>
        </p:nvSpPr>
        <p:spPr>
          <a:xfrm>
            <a:off x="0" y="3733920"/>
            <a:ext cx="9144000" cy="234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ry figure S3 ATP co-eluted with CDP-MEP and affected its detection with the SPE UPLC-MS metho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DP-MEP was not separated from many major cellular phosphor-compounds (such as ATP, CTP etc.) on the chromatography developed in this study (A). Because their high abundance, the major phosphor-compounds such as ATP may suppress signal of the compound co-eluted with them (known as ion-suppression), which could cause higher LOQ of CDP-MEP in cell extracts. To test this hypothesis, various concentrations of ATP were spiked into the solution containing CDP-MEP, and signal of CDP-MEP by the method developed in this study was indeed found to be gradually decreased (B). As a control, the ATP was also spiked into solution with DXP, a metabolite well separated from ATP. Signal of DXP was not affected by the addition of ATP (B), suggesting that higher LOQ of CDP-MEP could be caused by its co-elution with other abundant phospho-metabolites such as ATP etc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"/>
          <p:cNvSpPr/>
          <p:nvPr/>
        </p:nvSpPr>
        <p:spPr>
          <a:xfrm>
            <a:off x="791280" y="6271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7"/>
          <p:cNvSpPr/>
          <p:nvPr/>
        </p:nvSpPr>
        <p:spPr>
          <a:xfrm>
            <a:off x="5444280" y="6271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Kang</dc:creator>
  <dc:description/>
  <dc:language>en-US</dc:language>
  <cp:lastModifiedBy>Kang</cp:lastModifiedBy>
  <dcterms:modified xsi:type="dcterms:W3CDTF">2012-05-17T14:03:33Z</dcterms:modified>
  <cp:revision>6</cp:revision>
  <dc:subject/>
  <dc:title>PowerPoint Presentation</dc:title>
</cp:coreProperties>
</file>